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2408" y="-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6200" y="5867400"/>
            <a:ext cx="8915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rowth curves of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rnosum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. TMW 2.2021</a:t>
            </a:r>
            <a:r>
              <a:rPr lang="en-US" sz="14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B. TMW 2.2149 and </a:t>
            </a:r>
            <a:r>
              <a:rPr lang="en-US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osphoreum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. TMW 2.2103, D. TMW 2.2134 under different gas mixtures: air, N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100 %), N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C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70/30 %), 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C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70/30 %), 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N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70/30 %), 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C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N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21/30/49 %) measured as increase in OD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ver time (h).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0" y="304801"/>
            <a:ext cx="4300204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9666" y="351584"/>
            <a:ext cx="4267200" cy="2209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499" y="2756956"/>
            <a:ext cx="4252341" cy="22722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5712" y="2756955"/>
            <a:ext cx="4171154" cy="2371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76200" y="2192051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6200" y="494365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00982" y="2221469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00982" y="494365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5708" y="5312987"/>
            <a:ext cx="4880148" cy="162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54271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O:\WORKPLACE\Proteomics\Paper\ReadyforCorrections\HeatMap2149.png"/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F0F0F0"/>
              </a:clrFrom>
              <a:clrTo>
                <a:srgbClr val="F0F0F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9206" y="83354"/>
            <a:ext cx="2368393" cy="62649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O:\WORKPLACE\Proteomics\Paper\ReadyforCorrections\HeatMap2021.png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0F0F0"/>
              </a:clrFrom>
              <a:clrTo>
                <a:srgbClr val="F0F0F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1234" y="135836"/>
            <a:ext cx="2391555" cy="62124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78320" y="6046932"/>
            <a:ext cx="300773" cy="3538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A</a:t>
            </a:r>
            <a:endParaRPr lang="es-ES" dirty="0">
              <a:solidFill>
                <a:prstClr val="black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19600" y="6046972"/>
            <a:ext cx="282577" cy="353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B</a:t>
            </a:r>
            <a:endParaRPr lang="es-ES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51105" y="6400800"/>
            <a:ext cx="89154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supervised hierarchical clustering analysis of proteomics samples (LFQ data) from </a:t>
            </a:r>
            <a:r>
              <a:rPr lang="en-US" sz="105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05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nosum</a:t>
            </a:r>
            <a:r>
              <a:rPr lang="en-US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rains A. TMW 2.2021</a:t>
            </a:r>
            <a:r>
              <a:rPr lang="en-US" sz="105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B. TMW 2.2149.</a:t>
            </a:r>
            <a:endParaRPr lang="es-ES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96772"/>
              </p:ext>
            </p:extLst>
          </p:nvPr>
        </p:nvGraphicFramePr>
        <p:xfrm>
          <a:off x="1257635" y="790530"/>
          <a:ext cx="2193465" cy="442298"/>
        </p:xfrm>
        <a:graphic>
          <a:graphicData uri="http://schemas.openxmlformats.org/drawingml/2006/table">
            <a:tbl>
              <a:tblPr/>
              <a:tblGrid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</a:tblGrid>
              <a:tr h="44229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45" name="Table 4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9570645"/>
              </p:ext>
            </p:extLst>
          </p:nvPr>
        </p:nvGraphicFramePr>
        <p:xfrm>
          <a:off x="5190066" y="762000"/>
          <a:ext cx="2193465" cy="442298"/>
        </p:xfrm>
        <a:graphic>
          <a:graphicData uri="http://schemas.openxmlformats.org/drawingml/2006/table">
            <a:tbl>
              <a:tblPr/>
              <a:tblGrid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  <a:gridCol w="146231"/>
              </a:tblGrid>
              <a:tr h="44229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430488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 descr="O:\WORKPLACE\Proteomics\Paper\ReadyforCorrections\HeatMap2134.png"/>
          <p:cNvPicPr>
            <a:picLocks noChangeAspect="1" noChangeArrowheads="1"/>
          </p:cNvPicPr>
          <p:nvPr/>
        </p:nvPicPr>
        <p:blipFill>
          <a:blip r:embed="rId2">
            <a:clrChange>
              <a:clrFrom>
                <a:srgbClr val="F0F0F0"/>
              </a:clrFrom>
              <a:clrTo>
                <a:srgbClr val="F0F0F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1600" y="88709"/>
            <a:ext cx="2667000" cy="63120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O:\WORKPLACE\Proteomics\Paper\ReadyforCorrections\HeatMap2103.png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0F0F0"/>
              </a:clrFrom>
              <a:clrTo>
                <a:srgbClr val="F0F0F0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0" y="84476"/>
            <a:ext cx="2590800" cy="63120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51646" y="6410201"/>
            <a:ext cx="89154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0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supervised hierarchical clustering analysis of proteomics samples (LFQ data) from </a:t>
            </a:r>
            <a:r>
              <a:rPr lang="en-US" sz="105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05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osphoreum</a:t>
            </a:r>
            <a:r>
              <a:rPr lang="en-US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rains A. TMW 2.2103, B. TMW 2.2134.</a:t>
            </a:r>
            <a:endParaRPr lang="es-ES" sz="10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7998122"/>
              </p:ext>
            </p:extLst>
          </p:nvPr>
        </p:nvGraphicFramePr>
        <p:xfrm>
          <a:off x="1181103" y="719670"/>
          <a:ext cx="2514600" cy="442298"/>
        </p:xfrm>
        <a:graphic>
          <a:graphicData uri="http://schemas.openxmlformats.org/drawingml/2006/table">
            <a:tbl>
              <a:tblPr/>
              <a:tblGrid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</a:tblGrid>
              <a:tr h="442298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78320" y="6046932"/>
            <a:ext cx="300773" cy="3538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A</a:t>
            </a:r>
            <a:endParaRPr lang="es-ES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19600" y="6046972"/>
            <a:ext cx="282577" cy="353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B</a:t>
            </a:r>
            <a:endParaRPr lang="es-ES" dirty="0">
              <a:solidFill>
                <a:prstClr val="black"/>
              </a:solidFill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1620412"/>
              </p:ext>
            </p:extLst>
          </p:nvPr>
        </p:nvGraphicFramePr>
        <p:xfrm>
          <a:off x="5257800" y="715431"/>
          <a:ext cx="2514600" cy="442298"/>
        </p:xfrm>
        <a:graphic>
          <a:graphicData uri="http://schemas.openxmlformats.org/drawingml/2006/table">
            <a:tbl>
              <a:tblPr/>
              <a:tblGrid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  <a:gridCol w="139700"/>
              </a:tblGrid>
              <a:tr h="44229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N</a:t>
                      </a:r>
                      <a:r>
                        <a:rPr lang="es-ES" sz="600" b="0" i="0" u="none" strike="noStrike" baseline="-250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s-ES" sz="6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r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15" marR="5715" marT="5715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2425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00</Words>
  <Application>Microsoft Office PowerPoint</Application>
  <PresentationFormat>On-screen Show (4:3)</PresentationFormat>
  <Paragraphs>7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ra fuertes perez</dc:creator>
  <cp:lastModifiedBy>sandra fuertes perez</cp:lastModifiedBy>
  <cp:revision>11</cp:revision>
  <dcterms:created xsi:type="dcterms:W3CDTF">2006-08-16T00:00:00Z</dcterms:created>
  <dcterms:modified xsi:type="dcterms:W3CDTF">2022-01-28T20:59:47Z</dcterms:modified>
</cp:coreProperties>
</file>